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69EDD4-6B34-4BDE-9B7A-B818B7EDA714}" v="1" dt="2026-02-02T15:29:49.32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58394" autoAdjust="0"/>
  </p:normalViewPr>
  <p:slideViewPr>
    <p:cSldViewPr snapToGrid="0">
      <p:cViewPr varScale="1">
        <p:scale>
          <a:sx n="43" d="100"/>
          <a:sy n="43" d="100"/>
        </p:scale>
        <p:origin x="15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CC2868-3E66-4F31-AC03-5F087626D789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45BF7B-91E6-4885-BF9B-F74D92A080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30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/>
              <a:t>Supplementary</a:t>
            </a:r>
            <a:r>
              <a:rPr lang="es-ES" dirty="0"/>
              <a:t> Figure S1. NCDN </a:t>
            </a:r>
            <a:r>
              <a:rPr lang="es-ES" dirty="0" err="1"/>
              <a:t>expression</a:t>
            </a:r>
            <a:r>
              <a:rPr lang="es-ES" dirty="0"/>
              <a:t> in </a:t>
            </a:r>
            <a:r>
              <a:rPr lang="es-ES" dirty="0" err="1"/>
              <a:t>tissue</a:t>
            </a:r>
            <a:r>
              <a:rPr lang="es-ES" dirty="0"/>
              <a:t> simples and </a:t>
            </a:r>
            <a:r>
              <a:rPr lang="es-ES" dirty="0" err="1"/>
              <a:t>evaluation</a:t>
            </a:r>
            <a:r>
              <a:rPr lang="es-ES" dirty="0"/>
              <a:t> </a:t>
            </a:r>
            <a:r>
              <a:rPr lang="es-ES" dirty="0" err="1"/>
              <a:t>of</a:t>
            </a:r>
            <a:r>
              <a:rPr lang="es-ES" dirty="0"/>
              <a:t> </a:t>
            </a:r>
            <a:r>
              <a:rPr lang="es-ES" dirty="0" err="1"/>
              <a:t>its</a:t>
            </a:r>
            <a:r>
              <a:rPr lang="es-ES" dirty="0"/>
              <a:t> </a:t>
            </a:r>
            <a:r>
              <a:rPr lang="es-ES" dirty="0" err="1"/>
              <a:t>effect</a:t>
            </a:r>
            <a:r>
              <a:rPr lang="es-ES" dirty="0"/>
              <a:t> </a:t>
            </a:r>
            <a:r>
              <a:rPr lang="es-ES" dirty="0" err="1"/>
              <a:t>of</a:t>
            </a:r>
            <a:r>
              <a:rPr lang="es-ES" dirty="0"/>
              <a:t> NCDN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ell</a:t>
            </a:r>
            <a:r>
              <a:rPr lang="es-ES" dirty="0"/>
              <a:t> </a:t>
            </a:r>
            <a:r>
              <a:rPr lang="es-ES" dirty="0" err="1"/>
              <a:t>cycle</a:t>
            </a:r>
            <a:r>
              <a:rPr lang="es-ES" dirty="0"/>
              <a:t>. NCDN </a:t>
            </a:r>
            <a:r>
              <a:rPr lang="es-ES" dirty="0" err="1"/>
              <a:t>expression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COAD and READ </a:t>
            </a:r>
            <a:r>
              <a:rPr lang="es-ES" dirty="0" err="1"/>
              <a:t>datasets</a:t>
            </a:r>
            <a:r>
              <a:rPr lang="es-ES" dirty="0"/>
              <a:t> </a:t>
            </a:r>
            <a:r>
              <a:rPr lang="es-ES" dirty="0" err="1"/>
              <a:t>according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</a:t>
            </a:r>
            <a:r>
              <a:rPr lang="es-ES" dirty="0" err="1"/>
              <a:t>sample</a:t>
            </a:r>
            <a:r>
              <a:rPr lang="es-ES" dirty="0"/>
              <a:t> </a:t>
            </a:r>
            <a:r>
              <a:rPr lang="es-ES" dirty="0" err="1"/>
              <a:t>type</a:t>
            </a:r>
            <a:r>
              <a:rPr lang="es-ES" dirty="0"/>
              <a:t> and </a:t>
            </a:r>
            <a:r>
              <a:rPr lang="es-ES" dirty="0" err="1"/>
              <a:t>cancer</a:t>
            </a:r>
            <a:r>
              <a:rPr lang="es-ES" dirty="0"/>
              <a:t> </a:t>
            </a:r>
            <a:r>
              <a:rPr lang="es-ES" dirty="0" err="1"/>
              <a:t>stage</a:t>
            </a:r>
            <a:r>
              <a:rPr lang="es-ES" dirty="0"/>
              <a:t>. </a:t>
            </a:r>
            <a:r>
              <a:rPr lang="es-ES" dirty="0" err="1"/>
              <a:t>Graphs</a:t>
            </a:r>
            <a:r>
              <a:rPr lang="es-ES" dirty="0"/>
              <a:t> </a:t>
            </a:r>
            <a:r>
              <a:rPr lang="es-ES" dirty="0" err="1"/>
              <a:t>were</a:t>
            </a:r>
            <a:r>
              <a:rPr lang="es-ES" dirty="0"/>
              <a:t> </a:t>
            </a:r>
            <a:r>
              <a:rPr lang="es-ES" dirty="0" err="1"/>
              <a:t>obtained</a:t>
            </a:r>
            <a:r>
              <a:rPr lang="es-ES" dirty="0"/>
              <a:t> </a:t>
            </a:r>
            <a:r>
              <a:rPr lang="es-ES" dirty="0" err="1"/>
              <a:t>directly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UALCAN </a:t>
            </a:r>
            <a:r>
              <a:rPr lang="es-ES" dirty="0" err="1"/>
              <a:t>database</a:t>
            </a:r>
            <a:r>
              <a:rPr lang="es-ES"/>
              <a:t>. </a:t>
            </a: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45BF7B-91E6-4885-BF9B-F74D92A0802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91439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A0462F-0E01-4904-92F3-13F43C6248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E4F1EDA-88FA-4122-91B7-5F225C746B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4E1D337-C611-475D-8CFF-4D94EC24E5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0941658-6A8F-493A-BE56-97ED4E109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398F95B-B1C2-4334-8F5D-CD24437EB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4491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649C1C-C433-4819-9D0A-D9B14E17B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B50A860-F80A-4B0F-9249-4618B7E21B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F247428-0665-4DA7-B279-60392142C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4171A77-484F-467D-9715-83032A058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4D513A1-78F1-4897-83B7-7C5225C23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3763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A9175A2-9248-4C03-9C7E-6D8BD663B8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A6BF840-F436-4E8C-940E-0E52ABAFEF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2321B6A-DF0F-4C40-AEC9-511FAD1DF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6B7DE96-57FA-4E71-934E-170E4F114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758C6D4-435E-4019-9420-938D79AAB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1212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C912F1D-59F7-42E8-B574-4CAAAE6009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FF7CA26-E1F3-41D4-ABDD-47BEE734A1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C71B7C-BBCC-4B7E-9963-5EF74B762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98802DD-9885-4BB5-8247-DB804B5AB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E4E144E-CA99-4071-B958-E274B2A1F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1623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01FD5E-0A39-43FE-B496-EF860DA606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3110155-235A-4FEC-9F39-C01C7ABD56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BB5D642-1762-4F13-8342-306A8F35D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75D08B-CB9B-402A-8EE2-FD12F4486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4507094-A699-4FBC-AAC1-1B8422DCC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9772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75C4A2-D772-4AD4-88F5-60A53B3CD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A5E56B6-3004-43F1-87F1-196EF745DE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3AD0CB8-8EDE-4574-90C0-2CF28148DE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86FC01C-BB55-404F-97A2-D98D3E73A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15739B7-C9B4-43EC-A1F2-277288627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E048D0B-D7CF-4ADF-AB9C-C35C53A32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1806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3E76A5-BD51-4C3E-A8A2-6AD3B66E3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792C3AE-81F8-408C-B5A1-B0C665B365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6A46CCF-339B-4C61-BD37-DF4D2CF3F6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C6A1F17-44EF-4B1F-A244-42CF4AAB8C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DBA08F3-AAC3-41FA-B0F1-BB9CC31262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9970947-4832-43C6-8A8F-8A10D44B6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E4F2E40-1A35-414E-B025-FEF8053C2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4CD9AB04-62A0-40FF-995A-1A3B1AA80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559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2DAAA94-78FC-4AEE-8234-6C605E7F43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6853565-70C5-479B-B631-1C4209F85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F5ED8A8-E4D1-4A3F-8EA0-32C7AB42E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29A9001-9C14-45DA-A53C-CC0F75A0D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7056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A870077-B676-42EC-AFFF-1B692399F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23AEBD4-1F46-4CB9-B35D-7EF34833E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8CAB16E-4E3C-478D-B912-71FD29EF5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550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E91ED6B-27E4-4E11-9D52-4B3B872C77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BB18BB3-0F1E-4946-8080-49443F2C2D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B1F32ED-C9F0-4C91-980F-D093C53826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4025AEF-E878-45D6-B0EB-BFD484B8E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55E0A13-0621-4CFA-B637-27824D218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C892361-E4E0-4495-81B9-685BBAE15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4273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45C178B-7B9E-4DD0-A8A3-69C00E5A27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F5AF472-9A39-4ECD-8786-C14A5E4D6A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370BDB9-D812-4417-8E97-4B6C37D0E1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83C7EA5-6924-45BD-B4A1-1FD07D307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05E4FB5-1BAD-4087-A98F-6612C0AA8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CF320D4-8F16-47D1-B7CB-5A7F014EB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3829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265F66D-5787-4A08-AFBF-776D9308E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BB28CB6-C95D-477E-95A4-9EF1CBBA8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61C2B11-27AA-4A15-A686-995C587B57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DECF9-7351-4651-9314-4B76E59D57DE}" type="datetimeFigureOut">
              <a:rPr lang="es-ES" smtClean="0"/>
              <a:t>02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4AC6582-CF31-4CDA-8605-BE7B720553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9BA5943-DD8F-4816-B7AC-8C87ADCED7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45F59-B26D-4B13-9E9E-1D40DA45CAC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9558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4DA0292A-47CB-4461-AE56-606F4938FEA3}"/>
              </a:ext>
            </a:extLst>
          </p:cNvPr>
          <p:cNvSpPr txBox="1"/>
          <p:nvPr/>
        </p:nvSpPr>
        <p:spPr>
          <a:xfrm>
            <a:off x="0" y="640740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 Figure S1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B951EE6-EE93-49F3-B034-EA15C81D1A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077" y="81268"/>
            <a:ext cx="2743720" cy="2057790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2BA109CB-12FA-4EB0-B90A-E548CF260DE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5330" y="4276386"/>
            <a:ext cx="2743721" cy="2057791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46944866-2261-4600-8EC4-24D7003929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2278" y="2192083"/>
            <a:ext cx="2743722" cy="2057791"/>
          </a:xfrm>
          <a:prstGeom prst="rect">
            <a:avLst/>
          </a:prstGeom>
        </p:spPr>
      </p:pic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B7B82001-AE73-49A5-91D4-17C97F12B0FD}"/>
              </a:ext>
            </a:extLst>
          </p:cNvPr>
          <p:cNvCxnSpPr/>
          <p:nvPr/>
        </p:nvCxnSpPr>
        <p:spPr>
          <a:xfrm>
            <a:off x="5657850" y="627659"/>
            <a:ext cx="7429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8BF7006C-4DF4-465E-80D2-3CF35CC30677}"/>
              </a:ext>
            </a:extLst>
          </p:cNvPr>
          <p:cNvSpPr txBox="1"/>
          <p:nvPr/>
        </p:nvSpPr>
        <p:spPr>
          <a:xfrm>
            <a:off x="5563063" y="452870"/>
            <a:ext cx="937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 = 2.3e-5</a:t>
            </a:r>
          </a:p>
        </p:txBody>
      </p: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8D46D988-2C9E-46B0-B9E7-A6E195CD6BBE}"/>
              </a:ext>
            </a:extLst>
          </p:cNvPr>
          <p:cNvCxnSpPr>
            <a:cxnSpLocks/>
          </p:cNvCxnSpPr>
          <p:nvPr/>
        </p:nvCxnSpPr>
        <p:spPr>
          <a:xfrm>
            <a:off x="5657850" y="444130"/>
            <a:ext cx="12005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00E7B9FF-4A5C-469B-BB87-32ED53E751D7}"/>
              </a:ext>
            </a:extLst>
          </p:cNvPr>
          <p:cNvSpPr txBox="1"/>
          <p:nvPr/>
        </p:nvSpPr>
        <p:spPr>
          <a:xfrm>
            <a:off x="5563063" y="269187"/>
            <a:ext cx="15144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 = 1.6e-7</a:t>
            </a:r>
          </a:p>
        </p:txBody>
      </p:sp>
      <p:graphicFrame>
        <p:nvGraphicFramePr>
          <p:cNvPr id="14" name="Tabla 13">
            <a:extLst>
              <a:ext uri="{FF2B5EF4-FFF2-40B4-BE49-F238E27FC236}">
                <a16:creationId xmlns:a16="http://schemas.microsoft.com/office/drawing/2014/main" id="{D8A6FDD5-B7EE-4A38-9524-386059C5E8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5978314"/>
              </p:ext>
            </p:extLst>
          </p:nvPr>
        </p:nvGraphicFramePr>
        <p:xfrm>
          <a:off x="3465129" y="496588"/>
          <a:ext cx="1847149" cy="95072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46664">
                  <a:extLst>
                    <a:ext uri="{9D8B030D-6E8A-4147-A177-3AD203B41FA5}">
                      <a16:colId xmlns:a16="http://schemas.microsoft.com/office/drawing/2014/main" val="3027725312"/>
                    </a:ext>
                  </a:extLst>
                </a:gridCol>
                <a:gridCol w="900485">
                  <a:extLst>
                    <a:ext uri="{9D8B030D-6E8A-4147-A177-3AD203B41FA5}">
                      <a16:colId xmlns:a16="http://schemas.microsoft.com/office/drawing/2014/main" val="2149722084"/>
                    </a:ext>
                  </a:extLst>
                </a:gridCol>
              </a:tblGrid>
              <a:tr h="184463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rison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</a:t>
                      </a:r>
                      <a:r>
                        <a:rPr lang="es-ES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ce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3636827"/>
                  </a:ext>
                </a:extLst>
              </a:tr>
              <a:tr h="17546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1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E-05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563607"/>
                  </a:ext>
                </a:extLst>
              </a:tr>
              <a:tr h="17546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2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E-07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864700"/>
                  </a:ext>
                </a:extLst>
              </a:tr>
              <a:tr h="17546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3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E-09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7254288"/>
                  </a:ext>
                </a:extLst>
              </a:tr>
              <a:tr h="170966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4</a:t>
                      </a:r>
                      <a:endParaRPr lang="es-ES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E-06</a:t>
                      </a:r>
                      <a:endParaRPr lang="es-E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3236188"/>
                  </a:ext>
                </a:extLst>
              </a:tr>
            </a:tbl>
          </a:graphicData>
        </a:graphic>
      </p:graphicFrame>
      <p:graphicFrame>
        <p:nvGraphicFramePr>
          <p:cNvPr id="18" name="Tabla 17">
            <a:extLst>
              <a:ext uri="{FF2B5EF4-FFF2-40B4-BE49-F238E27FC236}">
                <a16:creationId xmlns:a16="http://schemas.microsoft.com/office/drawing/2014/main" id="{ADCD09C4-DCE0-4FA7-8E90-3ECDD87F6D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0334160"/>
              </p:ext>
            </p:extLst>
          </p:nvPr>
        </p:nvGraphicFramePr>
        <p:xfrm>
          <a:off x="3550608" y="2602136"/>
          <a:ext cx="1524000" cy="8343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val="2352647036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620275167"/>
                    </a:ext>
                  </a:extLst>
                </a:gridCol>
              </a:tblGrid>
              <a:tr h="581025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s-ES" sz="8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mparison</a:t>
                      </a:r>
                      <a:endParaRPr lang="es-ES" sz="8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s-ES" sz="8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atistical</a:t>
                      </a:r>
                      <a:r>
                        <a:rPr lang="es-ES" sz="8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8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gnificance</a:t>
                      </a:r>
                      <a:endParaRPr lang="es-ES" sz="8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7230827"/>
                  </a:ext>
                </a:extLst>
              </a:tr>
              <a:tr h="159438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</a:t>
                      </a:r>
                      <a:r>
                        <a:rPr lang="es-E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E-01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5353997"/>
                  </a:ext>
                </a:extLst>
              </a:tr>
            </a:tbl>
          </a:graphicData>
        </a:graphic>
      </p:graphicFrame>
      <p:graphicFrame>
        <p:nvGraphicFramePr>
          <p:cNvPr id="21" name="Tabla 20">
            <a:extLst>
              <a:ext uri="{FF2B5EF4-FFF2-40B4-BE49-F238E27FC236}">
                <a16:creationId xmlns:a16="http://schemas.microsoft.com/office/drawing/2014/main" id="{F50D3D19-E60F-4870-9A7C-691DC23C24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8363906"/>
              </p:ext>
            </p:extLst>
          </p:nvPr>
        </p:nvGraphicFramePr>
        <p:xfrm>
          <a:off x="3561524" y="4042689"/>
          <a:ext cx="1524000" cy="2057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val="183105423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897243800"/>
                    </a:ext>
                  </a:extLst>
                </a:gridCol>
              </a:tblGrid>
              <a:tr h="58102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rison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</a:t>
                      </a:r>
                      <a:r>
                        <a:rPr lang="es-ES" sz="8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ce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7062497"/>
                  </a:ext>
                </a:extLst>
              </a:tr>
              <a:tr h="37147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1</a:t>
                      </a:r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2E-01</a:t>
                      </a:r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650282"/>
                  </a:ext>
                </a:extLst>
              </a:tr>
              <a:tr h="37147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2</a:t>
                      </a:r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E-01</a:t>
                      </a:r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6104691"/>
                  </a:ext>
                </a:extLst>
              </a:tr>
              <a:tr h="371475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3</a:t>
                      </a:r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E-01</a:t>
                      </a:r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2264430"/>
                  </a:ext>
                </a:extLst>
              </a:tr>
              <a:tr h="361950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vs-Stage4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8E-02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40686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768377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83</Words>
  <Application>Microsoft Office PowerPoint</Application>
  <PresentationFormat>Panorámica</PresentationFormat>
  <Paragraphs>2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Garranzo Asensio</dc:creator>
  <cp:lastModifiedBy>Maria Garranzo Asensio</cp:lastModifiedBy>
  <cp:revision>14</cp:revision>
  <dcterms:created xsi:type="dcterms:W3CDTF">2025-02-10T09:29:02Z</dcterms:created>
  <dcterms:modified xsi:type="dcterms:W3CDTF">2026-02-02T15:31:03Z</dcterms:modified>
</cp:coreProperties>
</file>